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50" d="100"/>
          <a:sy n="50" d="100"/>
        </p:scale>
        <p:origin x="1934" y="8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30C3E-28AA-4084-9946-4D9167BEFBF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9A0597-C943-4E32-A775-71F6450B1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122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30C3E-28AA-4084-9946-4D9167BEFBF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9A0597-C943-4E32-A775-71F6450B1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79679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30C3E-28AA-4084-9946-4D9167BEFBF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9A0597-C943-4E32-A775-71F6450B1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64277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30C3E-28AA-4084-9946-4D9167BEFBF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9A0597-C943-4E32-A775-71F6450B1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333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30C3E-28AA-4084-9946-4D9167BEFBF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9A0597-C943-4E32-A775-71F6450B1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244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30C3E-28AA-4084-9946-4D9167BEFBF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9A0597-C943-4E32-A775-71F6450B1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03670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30C3E-28AA-4084-9946-4D9167BEFBF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9A0597-C943-4E32-A775-71F6450B1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80029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30C3E-28AA-4084-9946-4D9167BEFBF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9A0597-C943-4E32-A775-71F6450B1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8362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30C3E-28AA-4084-9946-4D9167BEFBF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9A0597-C943-4E32-A775-71F6450B1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0100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30C3E-28AA-4084-9946-4D9167BEFBF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9A0597-C943-4E32-A775-71F6450B1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5925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30C3E-28AA-4084-9946-4D9167BEFBF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9A0597-C943-4E32-A775-71F6450B1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8532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130C3E-28AA-4084-9946-4D9167BEFBF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9A0597-C943-4E32-A775-71F6450B17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23361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7" name="Picture 6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3406" y="679268"/>
            <a:ext cx="9341576" cy="5118463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Rectangle 4"/>
          <p:cNvSpPr>
            <a:spLocks noChangeArrowheads="1"/>
          </p:cNvSpPr>
          <p:nvPr/>
        </p:nvSpPr>
        <p:spPr bwMode="auto">
          <a:xfrm>
            <a:off x="777240" y="6009993"/>
            <a:ext cx="11414760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S3.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Correlation between β-</a:t>
            </a:r>
            <a:r>
              <a:rPr kumimoji="0" lang="en-US" altLang="en-US" sz="1200" b="0" i="0" u="sng" strike="noStrike" cap="none" normalizeH="0" baseline="0" dirty="0" err="1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BIHA</a:t>
            </a:r>
            <a:r>
              <a:rPr kumimoji="0" lang="en-US" altLang="en-US" sz="1200" b="0" i="0" u="none" strike="noStrike" cap="none" normalizeH="0" baseline="-30000" dirty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, 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rgbClr val="0D0D0D"/>
                </a:solidFill>
                <a:effectLst/>
                <a:latin typeface="Calibri" panose="020F0502020204030204" pitchFamily="34" charset="0"/>
                <a:ea typeface="MS Mincho"/>
                <a:cs typeface="Times New Roman" panose="02020603050405020304" pitchFamily="18" charset="0"/>
              </a:rPr>
              <a:t>µ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M) and </a:t>
            </a:r>
            <a:r>
              <a:rPr kumimoji="0" lang="en-US" altLang="en-US" sz="1200" b="0" i="0" u="sng" strike="noStrike" cap="none" normalizeH="0" baseline="0" dirty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IC</a:t>
            </a:r>
            <a:r>
              <a:rPr kumimoji="0" lang="en-US" altLang="en-US" sz="1200" b="0" i="0" u="none" strike="noStrike" cap="none" normalizeH="0" baseline="-30000" dirty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rgbClr val="0D0D0D"/>
                </a:solidFill>
                <a:effectLst/>
                <a:latin typeface="Calibri" panose="020F0502020204030204" pitchFamily="34" charset="0"/>
                <a:ea typeface="MS Mincho"/>
                <a:cs typeface="Times New Roman" panose="02020603050405020304" pitchFamily="18" charset="0"/>
              </a:rPr>
              <a:t>­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, 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rgbClr val="0D0D0D"/>
                </a:solidFill>
                <a:effectLst/>
                <a:latin typeface="Calibri" panose="020F0502020204030204" pitchFamily="34" charset="0"/>
                <a:ea typeface="MS Mincho"/>
                <a:cs typeface="Times New Roman" panose="02020603050405020304" pitchFamily="18" charset="0"/>
              </a:rPr>
              <a:t>µ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M) for benzylate chloroquinolines against sensitive strain 3D7. Compound 8d was removed from this analysis due to its inactivation of </a:t>
            </a:r>
            <a:r>
              <a:rPr kumimoji="0" lang="en-US" altLang="en-US" sz="1200" b="0" i="0" u="sng" strike="noStrike" cap="none" normalizeH="0" baseline="0" dirty="0" err="1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ozoin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formation, despite it had good </a:t>
            </a:r>
            <a:r>
              <a:rPr kumimoji="0" lang="en-US" altLang="en-US" sz="1200" b="0" i="0" u="sng" strike="noStrike" cap="none" normalizeH="0" baseline="0" dirty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effect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26790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5:55:07Z</dcterms:created>
  <dcterms:modified xsi:type="dcterms:W3CDTF">2020-08-04T16:30:46Z</dcterms:modified>
</cp:coreProperties>
</file>